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61" r:id="rId4"/>
    <p:sldId id="258" r:id="rId5"/>
    <p:sldId id="262" r:id="rId6"/>
    <p:sldId id="259" r:id="rId7"/>
    <p:sldId id="260" r:id="rId8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181" autoAdjust="0"/>
    <p:restoredTop sz="94660"/>
  </p:normalViewPr>
  <p:slideViewPr>
    <p:cSldViewPr snapToGrid="0">
      <p:cViewPr varScale="1">
        <p:scale>
          <a:sx n="87" d="100"/>
          <a:sy n="87" d="100"/>
        </p:scale>
        <p:origin x="90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948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9097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255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2440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879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5859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833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8438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2145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464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726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6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/>
          <p:cNvSpPr txBox="1"/>
          <p:nvPr/>
        </p:nvSpPr>
        <p:spPr>
          <a:xfrm>
            <a:off x="36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6000" y="3312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 rot="-5400000">
            <a:off x="-936000" y="4773593"/>
            <a:ext cx="2375999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 rot="-5400000">
            <a:off x="-1080000" y="1462918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テキスト ボックス 244"/>
          <p:cNvSpPr txBox="1"/>
          <p:nvPr/>
        </p:nvSpPr>
        <p:spPr>
          <a:xfrm>
            <a:off x="10080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テキスト ボックス 245"/>
          <p:cNvSpPr txBox="1"/>
          <p:nvPr/>
        </p:nvSpPr>
        <p:spPr>
          <a:xfrm>
            <a:off x="1008000" y="6418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180000"/>
            <a:ext cx="2952750" cy="295275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3456000"/>
            <a:ext cx="2952750" cy="295275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6660000"/>
            <a:ext cx="2952750" cy="2952750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6ABD253-9BDD-4647-8346-184F4E2D53F9}"/>
              </a:ext>
            </a:extLst>
          </p:cNvPr>
          <p:cNvSpPr txBox="1"/>
          <p:nvPr/>
        </p:nvSpPr>
        <p:spPr>
          <a:xfrm>
            <a:off x="36000" y="651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F47CF8F-AAB8-4EE2-8AF3-BA9E0475B5E1}"/>
              </a:ext>
            </a:extLst>
          </p:cNvPr>
          <p:cNvSpPr txBox="1"/>
          <p:nvPr/>
        </p:nvSpPr>
        <p:spPr>
          <a:xfrm rot="-5400000">
            <a:off x="-1078218" y="7862400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 under the ROC curve (AUC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94CD1FD-BAF6-499A-B8AE-7F3B170E98C4}"/>
              </a:ext>
            </a:extLst>
          </p:cNvPr>
          <p:cNvSpPr txBox="1"/>
          <p:nvPr/>
        </p:nvSpPr>
        <p:spPr>
          <a:xfrm>
            <a:off x="1008000" y="9622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ge 1: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DEG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0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96087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/>
          <p:cNvSpPr txBox="1"/>
          <p:nvPr/>
        </p:nvSpPr>
        <p:spPr>
          <a:xfrm>
            <a:off x="36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6000" y="3312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 rot="-5400000">
            <a:off x="-936000" y="4773593"/>
            <a:ext cx="2375999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 rot="-5400000">
            <a:off x="-1080000" y="1462918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テキスト ボックス 244"/>
          <p:cNvSpPr txBox="1"/>
          <p:nvPr/>
        </p:nvSpPr>
        <p:spPr>
          <a:xfrm>
            <a:off x="10080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テキスト ボックス 245"/>
          <p:cNvSpPr txBox="1"/>
          <p:nvPr/>
        </p:nvSpPr>
        <p:spPr>
          <a:xfrm>
            <a:off x="1008000" y="6418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180000"/>
            <a:ext cx="2952750" cy="295275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3456000"/>
            <a:ext cx="2952750" cy="295275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6660000"/>
            <a:ext cx="2952750" cy="2952750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2123E71-ED54-4CF2-A73C-24202D0254B5}"/>
              </a:ext>
            </a:extLst>
          </p:cNvPr>
          <p:cNvSpPr txBox="1"/>
          <p:nvPr/>
        </p:nvSpPr>
        <p:spPr>
          <a:xfrm>
            <a:off x="36000" y="651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E90124A-B507-463C-B821-475413CAFC64}"/>
              </a:ext>
            </a:extLst>
          </p:cNvPr>
          <p:cNvSpPr txBox="1"/>
          <p:nvPr/>
        </p:nvSpPr>
        <p:spPr>
          <a:xfrm rot="-5400000">
            <a:off x="-1078218" y="7862400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 under the ROC curve (AUC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7B7407F-DEE0-43E2-B5D7-07E186503B58}"/>
              </a:ext>
            </a:extLst>
          </p:cNvPr>
          <p:cNvSpPr txBox="1"/>
          <p:nvPr/>
        </p:nvSpPr>
        <p:spPr>
          <a:xfrm>
            <a:off x="1008000" y="9622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ge 2: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DEG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5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16830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/>
          <p:cNvSpPr txBox="1"/>
          <p:nvPr/>
        </p:nvSpPr>
        <p:spPr>
          <a:xfrm>
            <a:off x="36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6000" y="3312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 rot="-5400000">
            <a:off x="-936000" y="4773593"/>
            <a:ext cx="2375999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 rot="-5400000">
            <a:off x="-1080000" y="1462918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テキスト ボックス 244"/>
          <p:cNvSpPr txBox="1"/>
          <p:nvPr/>
        </p:nvSpPr>
        <p:spPr>
          <a:xfrm>
            <a:off x="10080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テキスト ボックス 245"/>
          <p:cNvSpPr txBox="1"/>
          <p:nvPr/>
        </p:nvSpPr>
        <p:spPr>
          <a:xfrm>
            <a:off x="1008000" y="6418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180000"/>
            <a:ext cx="2952750" cy="295275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3456000"/>
            <a:ext cx="2952750" cy="295275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6660000"/>
            <a:ext cx="2952750" cy="2952750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C0484E5-D523-480E-8D84-15C1A3CB2F39}"/>
              </a:ext>
            </a:extLst>
          </p:cNvPr>
          <p:cNvSpPr txBox="1"/>
          <p:nvPr/>
        </p:nvSpPr>
        <p:spPr>
          <a:xfrm>
            <a:off x="36000" y="651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5A847F0-5ED0-499A-8DEF-5BA6ADD12A03}"/>
              </a:ext>
            </a:extLst>
          </p:cNvPr>
          <p:cNvSpPr txBox="1"/>
          <p:nvPr/>
        </p:nvSpPr>
        <p:spPr>
          <a:xfrm rot="-5400000">
            <a:off x="-1078218" y="7862400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 under the ROC curve (AUC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2D48656-6223-41D5-9930-9EFBBF091C3D}"/>
              </a:ext>
            </a:extLst>
          </p:cNvPr>
          <p:cNvSpPr txBox="1"/>
          <p:nvPr/>
        </p:nvSpPr>
        <p:spPr>
          <a:xfrm>
            <a:off x="1008000" y="9622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ge 3: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DEG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35644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/>
          <p:cNvSpPr txBox="1"/>
          <p:nvPr/>
        </p:nvSpPr>
        <p:spPr>
          <a:xfrm>
            <a:off x="36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6000" y="3312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 rot="-5400000">
            <a:off x="-936000" y="4773593"/>
            <a:ext cx="2375999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 rot="-5400000">
            <a:off x="-1080000" y="1462918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テキスト ボックス 244"/>
          <p:cNvSpPr txBox="1"/>
          <p:nvPr/>
        </p:nvSpPr>
        <p:spPr>
          <a:xfrm>
            <a:off x="10080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テキスト ボックス 245"/>
          <p:cNvSpPr txBox="1"/>
          <p:nvPr/>
        </p:nvSpPr>
        <p:spPr>
          <a:xfrm>
            <a:off x="1008000" y="6418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180000"/>
            <a:ext cx="2952750" cy="295275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3456000"/>
            <a:ext cx="2952750" cy="295275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6660000"/>
            <a:ext cx="2952750" cy="2952750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F2A44D9-8ABA-4614-996A-D45E463BF0E1}"/>
              </a:ext>
            </a:extLst>
          </p:cNvPr>
          <p:cNvSpPr txBox="1"/>
          <p:nvPr/>
        </p:nvSpPr>
        <p:spPr>
          <a:xfrm>
            <a:off x="36000" y="651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FC4ACCF-BBFC-4936-B7C6-9B7853AE5097}"/>
              </a:ext>
            </a:extLst>
          </p:cNvPr>
          <p:cNvSpPr txBox="1"/>
          <p:nvPr/>
        </p:nvSpPr>
        <p:spPr>
          <a:xfrm rot="-5400000">
            <a:off x="-1078218" y="7862400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 under the ROC curve (AUC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3F6C8C4-A020-412D-A21D-79F4D3BBAFF3}"/>
              </a:ext>
            </a:extLst>
          </p:cNvPr>
          <p:cNvSpPr txBox="1"/>
          <p:nvPr/>
        </p:nvSpPr>
        <p:spPr>
          <a:xfrm>
            <a:off x="1008000" y="9622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ge 4: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DEG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487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/>
          <p:cNvSpPr txBox="1"/>
          <p:nvPr/>
        </p:nvSpPr>
        <p:spPr>
          <a:xfrm>
            <a:off x="36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6000" y="3312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 rot="-5400000">
            <a:off x="-936000" y="4773593"/>
            <a:ext cx="2375999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 rot="-5400000">
            <a:off x="-1080000" y="1462918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テキスト ボックス 244"/>
          <p:cNvSpPr txBox="1"/>
          <p:nvPr/>
        </p:nvSpPr>
        <p:spPr>
          <a:xfrm>
            <a:off x="10080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テキスト ボックス 245"/>
          <p:cNvSpPr txBox="1"/>
          <p:nvPr/>
        </p:nvSpPr>
        <p:spPr>
          <a:xfrm>
            <a:off x="1008000" y="6418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180000"/>
            <a:ext cx="2952750" cy="295275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3456000"/>
            <a:ext cx="2952750" cy="295275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6660000"/>
            <a:ext cx="2952750" cy="2952750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4B59437-30B2-4D01-96CE-C1899CAC173F}"/>
              </a:ext>
            </a:extLst>
          </p:cNvPr>
          <p:cNvSpPr txBox="1"/>
          <p:nvPr/>
        </p:nvSpPr>
        <p:spPr>
          <a:xfrm>
            <a:off x="36000" y="651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67F1A27-2D5F-467F-9595-8E5018153576}"/>
              </a:ext>
            </a:extLst>
          </p:cNvPr>
          <p:cNvSpPr txBox="1"/>
          <p:nvPr/>
        </p:nvSpPr>
        <p:spPr>
          <a:xfrm rot="-5400000">
            <a:off x="-1078218" y="7862400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 under the ROC curve (AUC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74F7155-A157-4D18-B7BF-148F5CD06763}"/>
              </a:ext>
            </a:extLst>
          </p:cNvPr>
          <p:cNvSpPr txBox="1"/>
          <p:nvPr/>
        </p:nvSpPr>
        <p:spPr>
          <a:xfrm>
            <a:off x="1008000" y="9622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ge 5: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DEG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5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97254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/>
          <p:cNvSpPr txBox="1"/>
          <p:nvPr/>
        </p:nvSpPr>
        <p:spPr>
          <a:xfrm>
            <a:off x="36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6000" y="3312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 rot="-5400000">
            <a:off x="-936000" y="4773593"/>
            <a:ext cx="2375999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 rot="-5400000">
            <a:off x="-1080000" y="1462918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テキスト ボックス 244"/>
          <p:cNvSpPr txBox="1"/>
          <p:nvPr/>
        </p:nvSpPr>
        <p:spPr>
          <a:xfrm>
            <a:off x="10080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テキスト ボックス 245"/>
          <p:cNvSpPr txBox="1"/>
          <p:nvPr/>
        </p:nvSpPr>
        <p:spPr>
          <a:xfrm>
            <a:off x="1008000" y="6418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180000"/>
            <a:ext cx="2952750" cy="295275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3456000"/>
            <a:ext cx="2952750" cy="295275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6660000"/>
            <a:ext cx="2952750" cy="2952750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AC97761-256E-4CA2-BE3C-3D485BADF151}"/>
              </a:ext>
            </a:extLst>
          </p:cNvPr>
          <p:cNvSpPr txBox="1"/>
          <p:nvPr/>
        </p:nvSpPr>
        <p:spPr>
          <a:xfrm>
            <a:off x="36000" y="651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D677439-12D8-469A-9916-A4DCF79ECA7A}"/>
              </a:ext>
            </a:extLst>
          </p:cNvPr>
          <p:cNvSpPr txBox="1"/>
          <p:nvPr/>
        </p:nvSpPr>
        <p:spPr>
          <a:xfrm rot="-5400000">
            <a:off x="-1078218" y="7862400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 under the ROC curve (AUC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55FFF4C-AF3E-4187-A41E-B8E74EA4828F}"/>
              </a:ext>
            </a:extLst>
          </p:cNvPr>
          <p:cNvSpPr txBox="1"/>
          <p:nvPr/>
        </p:nvSpPr>
        <p:spPr>
          <a:xfrm>
            <a:off x="1008000" y="9622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ge 6: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DEG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9868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/>
          <p:cNvSpPr txBox="1"/>
          <p:nvPr/>
        </p:nvSpPr>
        <p:spPr>
          <a:xfrm>
            <a:off x="36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6000" y="3312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 rot="-5400000">
            <a:off x="-936000" y="4773593"/>
            <a:ext cx="2375999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 rot="-5400000">
            <a:off x="-1080000" y="1462918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テキスト ボックス 244"/>
          <p:cNvSpPr txBox="1"/>
          <p:nvPr/>
        </p:nvSpPr>
        <p:spPr>
          <a:xfrm>
            <a:off x="10080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テキスト ボックス 245"/>
          <p:cNvSpPr txBox="1"/>
          <p:nvPr/>
        </p:nvSpPr>
        <p:spPr>
          <a:xfrm>
            <a:off x="1008000" y="6418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180000"/>
            <a:ext cx="2952750" cy="295275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3456000"/>
            <a:ext cx="2952750" cy="295275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6660000"/>
            <a:ext cx="2952750" cy="2952750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5869944-9E53-4750-A815-8AD63608D9E8}"/>
              </a:ext>
            </a:extLst>
          </p:cNvPr>
          <p:cNvSpPr txBox="1"/>
          <p:nvPr/>
        </p:nvSpPr>
        <p:spPr>
          <a:xfrm>
            <a:off x="36000" y="651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BEF925D-2DCF-4BFF-8253-869E7183373D}"/>
              </a:ext>
            </a:extLst>
          </p:cNvPr>
          <p:cNvSpPr txBox="1"/>
          <p:nvPr/>
        </p:nvSpPr>
        <p:spPr>
          <a:xfrm rot="-5400000">
            <a:off x="-1078218" y="7862400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 under the ROC curve (AUC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4A0E9C2-529B-4EE2-9BD7-844CE4198F80}"/>
              </a:ext>
            </a:extLst>
          </p:cNvPr>
          <p:cNvSpPr txBox="1"/>
          <p:nvPr/>
        </p:nvSpPr>
        <p:spPr>
          <a:xfrm>
            <a:off x="1008000" y="9622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ge 7: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DEG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2%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07727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68</TotalTime>
  <Words>399</Words>
  <Application>Microsoft Office PowerPoint</Application>
  <PresentationFormat>A4 210 x 297 mm</PresentationFormat>
  <Paragraphs>70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3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門田幸二</dc:creator>
  <cp:lastModifiedBy>門田幸二</cp:lastModifiedBy>
  <cp:revision>96</cp:revision>
  <dcterms:created xsi:type="dcterms:W3CDTF">2015-02-09T07:01:03Z</dcterms:created>
  <dcterms:modified xsi:type="dcterms:W3CDTF">2017-08-24T09:35:00Z</dcterms:modified>
</cp:coreProperties>
</file>